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32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m Hui Kheng" userId="20939611-dc46-461c-b286-1e84dc82e1a3" providerId="ADAL" clId="{8FCA7E79-4B9E-4C47-813A-9C4EEFFF93F4}"/>
    <pc:docChg chg="modSld">
      <pc:chgData name="Lim Hui Kheng" userId="20939611-dc46-461c-b286-1e84dc82e1a3" providerId="ADAL" clId="{8FCA7E79-4B9E-4C47-813A-9C4EEFFF93F4}" dt="2025-03-05T06:51:13.366" v="4" actId="2711"/>
      <pc:docMkLst>
        <pc:docMk/>
      </pc:docMkLst>
      <pc:sldChg chg="modSp mod">
        <pc:chgData name="Lim Hui Kheng" userId="20939611-dc46-461c-b286-1e84dc82e1a3" providerId="ADAL" clId="{8FCA7E79-4B9E-4C47-813A-9C4EEFFF93F4}" dt="2025-03-05T06:51:13.366" v="4" actId="2711"/>
        <pc:sldMkLst>
          <pc:docMk/>
          <pc:sldMk cId="3606080267" sldId="273"/>
        </pc:sldMkLst>
        <pc:spChg chg="mod">
          <ac:chgData name="Lim Hui Kheng" userId="20939611-dc46-461c-b286-1e84dc82e1a3" providerId="ADAL" clId="{8FCA7E79-4B9E-4C47-813A-9C4EEFFF93F4}" dt="2025-03-05T06:51:13.366" v="4" actId="2711"/>
          <ac:spMkLst>
            <pc:docMk/>
            <pc:sldMk cId="3606080267" sldId="273"/>
            <ac:spMk id="2" creationId="{42506472-832E-1A77-522E-B2710506B36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584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13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285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906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550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870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730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534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158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896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438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B5C5FED-50B2-4615-98A6-DAC2CEAAEFE5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AAF0690-E644-463B-BDFE-5ED6F79D6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999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19C0590-5EAA-DCDD-F697-42DE9EFD0CDB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928856"/>
          <a:ext cx="5915025" cy="76954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51256">
                  <a:extLst>
                    <a:ext uri="{9D8B030D-6E8A-4147-A177-3AD203B41FA5}">
                      <a16:colId xmlns:a16="http://schemas.microsoft.com/office/drawing/2014/main" val="1286485562"/>
                    </a:ext>
                  </a:extLst>
                </a:gridCol>
                <a:gridCol w="693700">
                  <a:extLst>
                    <a:ext uri="{9D8B030D-6E8A-4147-A177-3AD203B41FA5}">
                      <a16:colId xmlns:a16="http://schemas.microsoft.com/office/drawing/2014/main" val="3183631559"/>
                    </a:ext>
                  </a:extLst>
                </a:gridCol>
                <a:gridCol w="635370">
                  <a:extLst>
                    <a:ext uri="{9D8B030D-6E8A-4147-A177-3AD203B41FA5}">
                      <a16:colId xmlns:a16="http://schemas.microsoft.com/office/drawing/2014/main" val="1245536780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3077663707"/>
                    </a:ext>
                  </a:extLst>
                </a:gridCol>
                <a:gridCol w="616688">
                  <a:extLst>
                    <a:ext uri="{9D8B030D-6E8A-4147-A177-3AD203B41FA5}">
                      <a16:colId xmlns:a16="http://schemas.microsoft.com/office/drawing/2014/main" val="3680176810"/>
                    </a:ext>
                  </a:extLst>
                </a:gridCol>
                <a:gridCol w="595424">
                  <a:extLst>
                    <a:ext uri="{9D8B030D-6E8A-4147-A177-3AD203B41FA5}">
                      <a16:colId xmlns:a16="http://schemas.microsoft.com/office/drawing/2014/main" val="3125471669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56510597"/>
                    </a:ext>
                  </a:extLst>
                </a:gridCol>
                <a:gridCol w="691116">
                  <a:extLst>
                    <a:ext uri="{9D8B030D-6E8A-4147-A177-3AD203B41FA5}">
                      <a16:colId xmlns:a16="http://schemas.microsoft.com/office/drawing/2014/main" val="1217960637"/>
                    </a:ext>
                  </a:extLst>
                </a:gridCol>
                <a:gridCol w="634299">
                  <a:extLst>
                    <a:ext uri="{9D8B030D-6E8A-4147-A177-3AD203B41FA5}">
                      <a16:colId xmlns:a16="http://schemas.microsoft.com/office/drawing/2014/main" val="4148108299"/>
                    </a:ext>
                  </a:extLst>
                </a:gridCol>
              </a:tblGrid>
              <a:tr h="117878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BrO3 (</a:t>
                      </a:r>
                      <a:r>
                        <a:rPr lang="el-GR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1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4857652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% H2O 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57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0 ± 0.1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3.15 ± 0.3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8 ± 0.0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08 ± 0.2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2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1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11390641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7.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83 ± 0.3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3 ± 0.2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2.40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30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extLst>
                  <a:ext uri="{0D108BD9-81ED-4DB2-BD59-A6C34878D82A}">
                    <a16:rowId xmlns:a16="http://schemas.microsoft.com/office/drawing/2014/main" val="2721442004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7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70 ± 0.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0 ± 0.1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2.77 ± 0.5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1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6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extLst>
                  <a:ext uri="{0D108BD9-81ED-4DB2-BD59-A6C34878D82A}">
                    <a16:rowId xmlns:a16="http://schemas.microsoft.com/office/drawing/2014/main" val="810532126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73 ± 0.2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1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83 ± 0.5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43 ± 0.3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7 ± 0.1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7 ± 0.2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extLst>
                  <a:ext uri="{0D108BD9-81ED-4DB2-BD59-A6C34878D82A}">
                    <a16:rowId xmlns:a16="http://schemas.microsoft.com/office/drawing/2014/main" val="2569939041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7 ± 0.2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09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07 ± 0.7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10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87 ± 0.8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0046115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8701283-CFA2-2572-B9B2-E1888B41DC1A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1779685"/>
          <a:ext cx="5915025" cy="76691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40624">
                  <a:extLst>
                    <a:ext uri="{9D8B030D-6E8A-4147-A177-3AD203B41FA5}">
                      <a16:colId xmlns:a16="http://schemas.microsoft.com/office/drawing/2014/main" val="1014752483"/>
                    </a:ext>
                  </a:extLst>
                </a:gridCol>
                <a:gridCol w="701748">
                  <a:extLst>
                    <a:ext uri="{9D8B030D-6E8A-4147-A177-3AD203B41FA5}">
                      <a16:colId xmlns:a16="http://schemas.microsoft.com/office/drawing/2014/main" val="3536552712"/>
                    </a:ext>
                  </a:extLst>
                </a:gridCol>
                <a:gridCol w="637954">
                  <a:extLst>
                    <a:ext uri="{9D8B030D-6E8A-4147-A177-3AD203B41FA5}">
                      <a16:colId xmlns:a16="http://schemas.microsoft.com/office/drawing/2014/main" val="1936549775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2407746256"/>
                    </a:ext>
                  </a:extLst>
                </a:gridCol>
                <a:gridCol w="627321">
                  <a:extLst>
                    <a:ext uri="{9D8B030D-6E8A-4147-A177-3AD203B41FA5}">
                      <a16:colId xmlns:a16="http://schemas.microsoft.com/office/drawing/2014/main" val="1898981515"/>
                    </a:ext>
                  </a:extLst>
                </a:gridCol>
                <a:gridCol w="584791">
                  <a:extLst>
                    <a:ext uri="{9D8B030D-6E8A-4147-A177-3AD203B41FA5}">
                      <a16:colId xmlns:a16="http://schemas.microsoft.com/office/drawing/2014/main" val="377919537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3252312966"/>
                    </a:ext>
                  </a:extLst>
                </a:gridCol>
                <a:gridCol w="691116">
                  <a:extLst>
                    <a:ext uri="{9D8B030D-6E8A-4147-A177-3AD203B41FA5}">
                      <a16:colId xmlns:a16="http://schemas.microsoft.com/office/drawing/2014/main" val="166779948"/>
                    </a:ext>
                  </a:extLst>
                </a:gridCol>
                <a:gridCol w="634299">
                  <a:extLst>
                    <a:ext uri="{9D8B030D-6E8A-4147-A177-3AD203B41FA5}">
                      <a16:colId xmlns:a16="http://schemas.microsoft.com/office/drawing/2014/main" val="465087256"/>
                    </a:ext>
                  </a:extLst>
                </a:gridCol>
              </a:tblGrid>
              <a:tr h="109727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ugenol (</a:t>
                      </a:r>
                      <a:r>
                        <a:rPr lang="el-GR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1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1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1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1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1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4919907"/>
                  </a:ext>
                </a:extLst>
              </a:tr>
              <a:tr h="117986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0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7 ± 0.3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30 ± 1.5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0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13 ± 0.68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0 ± 0.1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0 ± 0.1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14012034"/>
                  </a:ext>
                </a:extLst>
              </a:tr>
              <a:tr h="117986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30 ± 0.12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3 ± 0.1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1.30 ± 0.9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17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13 ± 0.4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extLst>
                  <a:ext uri="{0D108BD9-81ED-4DB2-BD59-A6C34878D82A}">
                    <a16:rowId xmlns:a16="http://schemas.microsoft.com/office/drawing/2014/main" val="2048917315"/>
                  </a:ext>
                </a:extLst>
              </a:tr>
              <a:tr h="117986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00 ± 0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7 ± 0.2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0.80 ± 0.6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23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77 ± 0.8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extLst>
                  <a:ext uri="{0D108BD9-81ED-4DB2-BD59-A6C34878D82A}">
                    <a16:rowId xmlns:a16="http://schemas.microsoft.com/office/drawing/2014/main" val="863370615"/>
                  </a:ext>
                </a:extLst>
              </a:tr>
              <a:tr h="117986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23 ± 0.38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10 ± 0.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0.37 ± 1.7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43 ± 0.7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50 ± 07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/>
                </a:tc>
                <a:extLst>
                  <a:ext uri="{0D108BD9-81ED-4DB2-BD59-A6C34878D82A}">
                    <a16:rowId xmlns:a16="http://schemas.microsoft.com/office/drawing/2014/main" val="623128634"/>
                  </a:ext>
                </a:extLst>
              </a:tr>
              <a:tr h="117986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13 ± 0.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0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1.90 ± 1.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20 ± 0.2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83 ±1.0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899" marR="5899" marT="58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035673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2506472-832E-1A77-522E-B2710506B36B}"/>
              </a:ext>
            </a:extLst>
          </p:cNvPr>
          <p:cNvSpPr txBox="1"/>
          <p:nvPr/>
        </p:nvSpPr>
        <p:spPr>
          <a:xfrm>
            <a:off x="400050" y="531312"/>
            <a:ext cx="598646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SG" sz="1000" dirty="0">
                <a:effectLst/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3</a:t>
            </a:r>
            <a:r>
              <a:rPr lang="en-US" sz="1000" dirty="0">
                <a:latin typeface="Arial Narrow" panose="020B0606020202030204" pitchFamily="34" charset="0"/>
              </a:rPr>
              <a:t>: Cell phenotype and nuclear anomalies of chemicals with equivocal or unexpected results tested in </a:t>
            </a:r>
            <a:r>
              <a:rPr lang="en-SG" sz="1000" dirty="0"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Cyt assay</a:t>
            </a:r>
            <a:r>
              <a:rPr lang="en-US" sz="1000" dirty="0">
                <a:latin typeface="Arial Narrow" panose="020B0606020202030204" pitchFamily="34" charset="0"/>
              </a:rPr>
              <a:t> in 3D </a:t>
            </a:r>
            <a:r>
              <a:rPr lang="en-US" sz="1000" dirty="0" err="1">
                <a:latin typeface="Arial Narrow" panose="020B0606020202030204" pitchFamily="34" charset="0"/>
              </a:rPr>
              <a:t>EpiIntestinal</a:t>
            </a:r>
            <a:r>
              <a:rPr lang="en-US" sz="1000" dirty="0">
                <a:latin typeface="Arial Narrow" panose="020B0606020202030204" pitchFamily="34" charset="0"/>
              </a:rPr>
              <a:t>™ tissu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96A553C-F72C-12B2-A963-05871986067E}"/>
              </a:ext>
            </a:extLst>
          </p:cNvPr>
          <p:cNvSpPr txBox="1"/>
          <p:nvPr/>
        </p:nvSpPr>
        <p:spPr>
          <a:xfrm>
            <a:off x="474014" y="3390470"/>
            <a:ext cx="598646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SG" sz="1000" dirty="0">
                <a:solidFill>
                  <a:srgbClr val="000000"/>
                </a:solidFill>
                <a:latin typeface="Arial Narrow" panose="020B0606020202030204" pitchFamily="34" charset="0"/>
              </a:rPr>
              <a:t>KBrO</a:t>
            </a:r>
            <a:r>
              <a:rPr lang="en-SG" sz="1000" baseline="-25000" dirty="0">
                <a:solidFill>
                  <a:srgbClr val="000000"/>
                </a:solidFill>
                <a:latin typeface="Arial Narrow" panose="020B0606020202030204" pitchFamily="34" charset="0"/>
              </a:rPr>
              <a:t>3</a:t>
            </a:r>
            <a:r>
              <a:rPr lang="en-SG" sz="1000" dirty="0">
                <a:solidFill>
                  <a:srgbClr val="000000"/>
                </a:solidFill>
                <a:latin typeface="Arial Narrow" panose="020B0606020202030204" pitchFamily="34" charset="0"/>
              </a:rPr>
              <a:t>, </a:t>
            </a:r>
            <a:r>
              <a:rPr lang="en-SG" sz="1000" b="0" i="0" u="none" strike="noStrike" baseline="0" dirty="0">
                <a:effectLst/>
                <a:latin typeface="Arial Narrow" panose="020B0606020202030204" pitchFamily="34" charset="0"/>
              </a:rPr>
              <a:t>Potassium bromate</a:t>
            </a:r>
            <a:r>
              <a:rPr lang="en-SG" sz="1000" b="1" u="none" strike="noStrike" dirty="0">
                <a:solidFill>
                  <a:srgbClr val="000000"/>
                </a:solidFill>
                <a:effectLst/>
                <a:latin typeface="Arial Narrow" panose="020B0606020202030204" pitchFamily="34" charset="0"/>
              </a:rPr>
              <a:t>; </a:t>
            </a:r>
            <a:r>
              <a:rPr lang="en-SG" sz="1000" u="none" strike="noStrike" dirty="0">
                <a:solidFill>
                  <a:srgbClr val="000000"/>
                </a:solidFill>
                <a:effectLst/>
                <a:latin typeface="Arial Narrow" panose="020B0606020202030204" pitchFamily="34" charset="0"/>
              </a:rPr>
              <a:t>EUG, Eugenol; MCT, Monocrotaline; </a:t>
            </a:r>
            <a:r>
              <a:rPr lang="en-US" sz="1000" dirty="0">
                <a:latin typeface="Arial Narrow" panose="020B0606020202030204" pitchFamily="34" charset="0"/>
              </a:rPr>
              <a:t>MN, micronuclei; Buds, nuclear buds, Mono, mononucleated cells (basal and differentiated); BN, binucleated cells; CC, condensed chromatin; KR, karyorrhexis; PY, pyknosis; KL, </a:t>
            </a:r>
            <a:r>
              <a:rPr lang="en-US" sz="1000" dirty="0" err="1">
                <a:latin typeface="Arial Narrow" panose="020B0606020202030204" pitchFamily="34" charset="0"/>
              </a:rPr>
              <a:t>karyolysis</a:t>
            </a:r>
            <a:endParaRPr lang="en-US" sz="1000" dirty="0">
              <a:latin typeface="Arial Narrow" panose="020B0606020202030204" pitchFamily="34" charset="0"/>
            </a:endParaRP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024377EE-DC8A-47B3-CE38-A094AA68EB40}"/>
              </a:ext>
            </a:extLst>
          </p:cNvPr>
          <p:cNvGraphicFramePr>
            <a:graphicFrameLocks noGrp="1"/>
          </p:cNvGraphicFramePr>
          <p:nvPr/>
        </p:nvGraphicFramePr>
        <p:xfrm>
          <a:off x="474014" y="2614305"/>
          <a:ext cx="5915027" cy="76294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74541">
                  <a:extLst>
                    <a:ext uri="{9D8B030D-6E8A-4147-A177-3AD203B41FA5}">
                      <a16:colId xmlns:a16="http://schemas.microsoft.com/office/drawing/2014/main" val="375705817"/>
                    </a:ext>
                  </a:extLst>
                </a:gridCol>
                <a:gridCol w="574158">
                  <a:extLst>
                    <a:ext uri="{9D8B030D-6E8A-4147-A177-3AD203B41FA5}">
                      <a16:colId xmlns:a16="http://schemas.microsoft.com/office/drawing/2014/main" val="1030940651"/>
                    </a:ext>
                  </a:extLst>
                </a:gridCol>
                <a:gridCol w="606056">
                  <a:extLst>
                    <a:ext uri="{9D8B030D-6E8A-4147-A177-3AD203B41FA5}">
                      <a16:colId xmlns:a16="http://schemas.microsoft.com/office/drawing/2014/main" val="4072581101"/>
                    </a:ext>
                  </a:extLst>
                </a:gridCol>
                <a:gridCol w="680484">
                  <a:extLst>
                    <a:ext uri="{9D8B030D-6E8A-4147-A177-3AD203B41FA5}">
                      <a16:colId xmlns:a16="http://schemas.microsoft.com/office/drawing/2014/main" val="1231152378"/>
                    </a:ext>
                  </a:extLst>
                </a:gridCol>
                <a:gridCol w="627321">
                  <a:extLst>
                    <a:ext uri="{9D8B030D-6E8A-4147-A177-3AD203B41FA5}">
                      <a16:colId xmlns:a16="http://schemas.microsoft.com/office/drawing/2014/main" val="1998664023"/>
                    </a:ext>
                  </a:extLst>
                </a:gridCol>
                <a:gridCol w="637953">
                  <a:extLst>
                    <a:ext uri="{9D8B030D-6E8A-4147-A177-3AD203B41FA5}">
                      <a16:colId xmlns:a16="http://schemas.microsoft.com/office/drawing/2014/main" val="3794830618"/>
                    </a:ext>
                  </a:extLst>
                </a:gridCol>
                <a:gridCol w="627321">
                  <a:extLst>
                    <a:ext uri="{9D8B030D-6E8A-4147-A177-3AD203B41FA5}">
                      <a16:colId xmlns:a16="http://schemas.microsoft.com/office/drawing/2014/main" val="3228727303"/>
                    </a:ext>
                  </a:extLst>
                </a:gridCol>
                <a:gridCol w="606056">
                  <a:extLst>
                    <a:ext uri="{9D8B030D-6E8A-4147-A177-3AD203B41FA5}">
                      <a16:colId xmlns:a16="http://schemas.microsoft.com/office/drawing/2014/main" val="3111954229"/>
                    </a:ext>
                  </a:extLst>
                </a:gridCol>
                <a:gridCol w="581137">
                  <a:extLst>
                    <a:ext uri="{9D8B030D-6E8A-4147-A177-3AD203B41FA5}">
                      <a16:colId xmlns:a16="http://schemas.microsoft.com/office/drawing/2014/main" val="1805710448"/>
                    </a:ext>
                  </a:extLst>
                </a:gridCol>
              </a:tblGrid>
              <a:tr h="97420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CT (</a:t>
                      </a:r>
                      <a:r>
                        <a:rPr lang="el-GR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1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1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1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1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1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1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1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1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1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396828"/>
                  </a:ext>
                </a:extLst>
              </a:tr>
              <a:tr h="104753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.72 ± 0.22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32 ± 0.02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3.05 ± 0.26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60 ± 0.06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4.07 ± 0.03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25 ± 0.03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397122521"/>
                  </a:ext>
                </a:extLst>
              </a:tr>
              <a:tr h="10475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0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.97 ± 0.18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40 ± 0.0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1.97 ± 0.23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63 ± 0.09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4.37 ± 0.09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63 ± 0.12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extLst>
                  <a:ext uri="{0D108BD9-81ED-4DB2-BD59-A6C34878D82A}">
                    <a16:rowId xmlns:a16="http://schemas.microsoft.com/office/drawing/2014/main" val="4203370147"/>
                  </a:ext>
                </a:extLst>
              </a:tr>
              <a:tr h="114294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20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2.00 ± 0.21*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57 ± 0.18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2.33 ± 0.49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63 ± 0.18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4.03 ± 0.097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43 ± 0.15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extLst>
                  <a:ext uri="{0D108BD9-81ED-4DB2-BD59-A6C34878D82A}">
                    <a16:rowId xmlns:a16="http://schemas.microsoft.com/office/drawing/2014/main" val="1973298849"/>
                  </a:ext>
                </a:extLst>
              </a:tr>
              <a:tr h="104753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3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2.53 ± 0.34*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53 ± 0.07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1.70 ± 0.21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70 ± 0.15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4.00 ± 0.1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50 ± 0.12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/>
                </a:tc>
                <a:extLst>
                  <a:ext uri="{0D108BD9-81ED-4DB2-BD59-A6C34878D82A}">
                    <a16:rowId xmlns:a16="http://schemas.microsoft.com/office/drawing/2014/main" val="1555359256"/>
                  </a:ext>
                </a:extLst>
              </a:tr>
              <a:tr h="104753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40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2.53 ± 0.29*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50 ± 0.06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1.23 ± 0.13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83 ± 0.15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4.30 ± 0.21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60 ± 0.10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238" marR="5238" marT="52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32120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06080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8</Words>
  <Application>Microsoft Office PowerPoint</Application>
  <PresentationFormat>A4 Paper (210x297 mm)</PresentationFormat>
  <Paragraphs>1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Arial Narro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m Hui Kheng</dc:creator>
  <cp:lastModifiedBy>Lim Hui Kheng</cp:lastModifiedBy>
  <cp:revision>1</cp:revision>
  <dcterms:created xsi:type="dcterms:W3CDTF">2025-01-27T06:17:49Z</dcterms:created>
  <dcterms:modified xsi:type="dcterms:W3CDTF">2025-03-05T06:51:19Z</dcterms:modified>
</cp:coreProperties>
</file>